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0" r:id="rId2"/>
    <p:sldId id="296" r:id="rId3"/>
    <p:sldId id="297" r:id="rId4"/>
    <p:sldId id="298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1119" y="6381328"/>
            <a:ext cx="7703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9 Fig. Histograms of penalty scores (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GC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SR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D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C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and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W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at initial and best cycles for Fig 2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" y="0"/>
            <a:ext cx="7610305" cy="617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9832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" y="0"/>
            <a:ext cx="7525817" cy="6174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41119" y="6381328"/>
            <a:ext cx="820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9 Fig. Histograms of penalty scores (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GC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SR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D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C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and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W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at initial and best cycles for Fig 2 (continued)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04770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33403" y="446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" y="0"/>
            <a:ext cx="7525817" cy="6174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41119" y="6381328"/>
            <a:ext cx="820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9 Fig. Histograms of penalty scores (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GC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SR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D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C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and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W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at initial and best cycles for Fig 2 (continued)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78333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6991" y="4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680" y="0"/>
            <a:ext cx="7525817" cy="6174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41119" y="6381328"/>
            <a:ext cx="820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9 Fig. Histograms of penalty scores (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GC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SR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HD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C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, and P</a:t>
            </a:r>
            <a:r>
              <a:rPr lang="en-US" altLang="ko-KR" sz="1200" baseline="-25000" dirty="0">
                <a:latin typeface="Arial" pitchFamily="34" charset="0"/>
                <a:cs typeface="Arial" pitchFamily="34" charset="0"/>
              </a:rPr>
              <a:t>WT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at initial and best cycles for Fig 2 (continued)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8254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130</Words>
  <Application>Microsoft Office PowerPoint</Application>
  <PresentationFormat>On-screen Show 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43:05Z</dcterms:modified>
</cp:coreProperties>
</file>